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101" autoAdjust="0"/>
    <p:restoredTop sz="94660"/>
  </p:normalViewPr>
  <p:slideViewPr>
    <p:cSldViewPr snapToGrid="0">
      <p:cViewPr>
        <p:scale>
          <a:sx n="100" d="100"/>
          <a:sy n="100" d="100"/>
        </p:scale>
        <p:origin x="9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48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09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55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4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7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8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83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43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14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46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3492000"/>
            <a:ext cx="6191250" cy="28575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000" y="180000"/>
            <a:ext cx="2952750" cy="295275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6" name="テキスト ボックス 165"/>
          <p:cNvSpPr txBox="1"/>
          <p:nvPr/>
        </p:nvSpPr>
        <p:spPr>
          <a:xfrm>
            <a:off x="3420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テキスト ボックス 174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テキスト ボックス 175"/>
          <p:cNvSpPr txBox="1"/>
          <p:nvPr/>
        </p:nvSpPr>
        <p:spPr>
          <a:xfrm rot="-5400000">
            <a:off x="2332800" y="1462919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テキスト ボックス 189"/>
          <p:cNvSpPr txBox="1"/>
          <p:nvPr/>
        </p:nvSpPr>
        <p:spPr>
          <a:xfrm>
            <a:off x="44856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5" name="テキスト ボックス 24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BF4EA14-0015-4A97-9530-7954F98ED7C2}"/>
              </a:ext>
            </a:extLst>
          </p:cNvPr>
          <p:cNvSpPr txBox="1"/>
          <p:nvPr/>
        </p:nvSpPr>
        <p:spPr>
          <a:xfrm>
            <a:off x="36000" y="642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72EA6A5-E61C-4AF9-9465-05DBB9253B51}"/>
              </a:ext>
            </a:extLst>
          </p:cNvPr>
          <p:cNvSpPr txBox="1"/>
          <p:nvPr/>
        </p:nvSpPr>
        <p:spPr>
          <a:xfrm rot="-5400000">
            <a:off x="-1080000" y="7853687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595264E-D36D-4EBF-A94E-0C49AE034633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id="{52FEAE6F-214C-4E0F-AE8A-DBC412C62EE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570000"/>
            <a:ext cx="2952750" cy="2952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9608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000" y="180000"/>
            <a:ext cx="2952750" cy="295275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420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-5400000">
            <a:off x="2332800" y="1462919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44856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al-to-noise ratio (SNR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8327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59</TotalTime>
  <Words>90</Words>
  <Application>Microsoft Office PowerPoint</Application>
  <PresentationFormat>A4 210 x 297 mm</PresentationFormat>
  <Paragraphs>1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105</cp:revision>
  <dcterms:created xsi:type="dcterms:W3CDTF">2015-02-09T07:01:03Z</dcterms:created>
  <dcterms:modified xsi:type="dcterms:W3CDTF">2017-09-02T02:55:20Z</dcterms:modified>
</cp:coreProperties>
</file>